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notesMasterIdLst>
    <p:notesMasterId r:id="rId9"/>
  </p:notesMasterIdLst>
  <p:sldIdLst>
    <p:sldId id="268" r:id="rId2"/>
    <p:sldId id="260" r:id="rId3"/>
    <p:sldId id="263" r:id="rId4"/>
    <p:sldId id="266" r:id="rId5"/>
    <p:sldId id="269" r:id="rId6"/>
    <p:sldId id="270" r:id="rId7"/>
    <p:sldId id="272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29BE2B2-3467-4934-6E27-97761A24EC54}" name="Kate Mathers" initials="KM" userId="S::gykm6@lunet.lboro.ac.uk::4d07b8d5-1443-4e4a-88c9-95afa2dd68c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21" autoAdjust="0"/>
    <p:restoredTop sz="90129" autoAdjust="0"/>
  </p:normalViewPr>
  <p:slideViewPr>
    <p:cSldViewPr snapToGrid="0">
      <p:cViewPr varScale="1">
        <p:scale>
          <a:sx n="43" d="100"/>
          <a:sy n="43" d="100"/>
        </p:scale>
        <p:origin x="2176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y%20Drive\Sediment%20project%20details\Sediment%20node%20%20_%20gradient\Writeup\Comments%20round%202\Submission\Revisions\Traits_habtiat%20stuff_editing%2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1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y%20Drive\Sediment%20project%20details\Sediment%20node%20%20_%20gradient\Writeup\Comments%20round%202\Submission\Revisions\Traits_habtiat%20stuff_editing%20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890364474975408"/>
          <c:y val="2.8776858173984635E-2"/>
          <c:w val="0.797952508827666"/>
          <c:h val="0.620163505534062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A$4</c:f>
              <c:strCache>
                <c:ptCount val="1"/>
                <c:pt idx="0">
                  <c:v>Glatt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B$15:$J$15</c:f>
              <c:strCache>
                <c:ptCount val="9"/>
                <c:pt idx="0">
                  <c:v>boulders/cobbles</c:v>
                </c:pt>
                <c:pt idx="1">
                  <c:v>gravel</c:v>
                </c:pt>
                <c:pt idx="2">
                  <c:v>sand</c:v>
                </c:pt>
                <c:pt idx="3">
                  <c:v>silt</c:v>
                </c:pt>
                <c:pt idx="4">
                  <c:v>macrophytes</c:v>
                </c:pt>
                <c:pt idx="5">
                  <c:v>microphytes</c:v>
                </c:pt>
                <c:pt idx="6">
                  <c:v>roots</c:v>
                </c:pt>
                <c:pt idx="7">
                  <c:v>organic detritus</c:v>
                </c:pt>
                <c:pt idx="8">
                  <c:v>mud</c:v>
                </c:pt>
              </c:strCache>
            </c:strRef>
          </c:cat>
          <c:val>
            <c:numRef>
              <c:f>Sheet2!$B$16:$J$16</c:f>
              <c:numCache>
                <c:formatCode>0.00</c:formatCode>
                <c:ptCount val="9"/>
                <c:pt idx="0">
                  <c:v>0.21961879255048139</c:v>
                </c:pt>
                <c:pt idx="1">
                  <c:v>8.7251378707735444E-2</c:v>
                </c:pt>
                <c:pt idx="2">
                  <c:v>8.7144240958282687E-2</c:v>
                </c:pt>
                <c:pt idx="3">
                  <c:v>4.1540315050751488E-2</c:v>
                </c:pt>
                <c:pt idx="4">
                  <c:v>0.2587258635313664</c:v>
                </c:pt>
                <c:pt idx="5">
                  <c:v>4.1305491893727189E-2</c:v>
                </c:pt>
                <c:pt idx="6">
                  <c:v>6.180987945219444E-2</c:v>
                </c:pt>
                <c:pt idx="7">
                  <c:v>8.4174902685339115E-2</c:v>
                </c:pt>
                <c:pt idx="8">
                  <c:v>0.118429135170121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C49-4B75-A33A-CA1E7E0B204A}"/>
            </c:ext>
          </c:extLst>
        </c:ser>
        <c:ser>
          <c:idx val="1"/>
          <c:order val="1"/>
          <c:tx>
            <c:strRef>
              <c:f>Sheet2!$A$5</c:f>
              <c:strCache>
                <c:ptCount val="1"/>
                <c:pt idx="0">
                  <c:v>Necker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B$15:$J$15</c:f>
              <c:strCache>
                <c:ptCount val="9"/>
                <c:pt idx="0">
                  <c:v>boulders/cobbles</c:v>
                </c:pt>
                <c:pt idx="1">
                  <c:v>gravel</c:v>
                </c:pt>
                <c:pt idx="2">
                  <c:v>sand</c:v>
                </c:pt>
                <c:pt idx="3">
                  <c:v>silt</c:v>
                </c:pt>
                <c:pt idx="4">
                  <c:v>macrophytes</c:v>
                </c:pt>
                <c:pt idx="5">
                  <c:v>microphytes</c:v>
                </c:pt>
                <c:pt idx="6">
                  <c:v>roots</c:v>
                </c:pt>
                <c:pt idx="7">
                  <c:v>organic detritus</c:v>
                </c:pt>
                <c:pt idx="8">
                  <c:v>mud</c:v>
                </c:pt>
              </c:strCache>
            </c:strRef>
          </c:cat>
          <c:val>
            <c:numRef>
              <c:f>Sheet2!$B$17:$J$17</c:f>
              <c:numCache>
                <c:formatCode>0.00</c:formatCode>
                <c:ptCount val="9"/>
                <c:pt idx="0">
                  <c:v>0.2620170176731263</c:v>
                </c:pt>
                <c:pt idx="1">
                  <c:v>0.17287589233290593</c:v>
                </c:pt>
                <c:pt idx="2">
                  <c:v>0.11743133688835046</c:v>
                </c:pt>
                <c:pt idx="3">
                  <c:v>5.7530704589528123E-2</c:v>
                </c:pt>
                <c:pt idx="4">
                  <c:v>0.20398844493867119</c:v>
                </c:pt>
                <c:pt idx="5">
                  <c:v>8.5470085470085461E-3</c:v>
                </c:pt>
                <c:pt idx="6">
                  <c:v>5.2554346106382314E-2</c:v>
                </c:pt>
                <c:pt idx="7">
                  <c:v>8.0497682307637042E-2</c:v>
                </c:pt>
                <c:pt idx="8">
                  <c:v>4.45575666163901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C49-4B75-A33A-CA1E7E0B20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43717480"/>
        <c:axId val="943717120"/>
      </c:barChart>
      <c:catAx>
        <c:axId val="9437174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 b="0" i="0" u="none" strike="noStrike" kern="1200" baseline="0" dirty="0">
                    <a:solidFill>
                      <a:srgbClr val="000000"/>
                    </a:solidFill>
                    <a:effectLst/>
                    <a:latin typeface="Aptos Narrow" panose="020B0004020202020204" pitchFamily="34" charset="0"/>
                  </a:rPr>
                  <a:t>Substrate (</a:t>
                </a:r>
                <a:r>
                  <a:rPr lang="en-GB" sz="1200" b="0" i="0" u="none" strike="noStrike" kern="1200" baseline="0" dirty="0" err="1">
                    <a:solidFill>
                      <a:srgbClr val="000000"/>
                    </a:solidFill>
                    <a:effectLst/>
                    <a:latin typeface="Aptos Narrow" panose="020B0004020202020204" pitchFamily="34" charset="0"/>
                  </a:rPr>
                  <a:t>preferendum</a:t>
                </a:r>
                <a:r>
                  <a:rPr lang="en-GB" sz="1200" b="0" i="0" u="none" strike="noStrike" kern="1200" baseline="0" dirty="0">
                    <a:solidFill>
                      <a:srgbClr val="000000"/>
                    </a:solidFill>
                    <a:effectLst/>
                    <a:latin typeface="Aptos Narrow" panose="020B0004020202020204" pitchFamily="34" charset="0"/>
                  </a:rPr>
                  <a:t>))</a:t>
                </a:r>
                <a:endParaRPr lang="en-US" sz="1200" b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43717120"/>
        <c:crosses val="autoZero"/>
        <c:auto val="1"/>
        <c:lblAlgn val="ctr"/>
        <c:lblOffset val="100"/>
        <c:noMultiLvlLbl val="0"/>
      </c:catAx>
      <c:valAx>
        <c:axId val="943717120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43717480"/>
        <c:crosses val="autoZero"/>
        <c:crossBetween val="between"/>
        <c:majorUnit val="0.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948432449829782"/>
          <c:y val="6.6206263224189169E-2"/>
          <c:w val="0.78604674091904325"/>
          <c:h val="0.7566846143345555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A$4</c:f>
              <c:strCache>
                <c:ptCount val="1"/>
                <c:pt idx="0">
                  <c:v>Glatt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B$7:$E$7</c:f>
              <c:strCache>
                <c:ptCount val="4"/>
                <c:pt idx="0">
                  <c:v>null</c:v>
                </c:pt>
                <c:pt idx="1">
                  <c:v>slow</c:v>
                </c:pt>
                <c:pt idx="2">
                  <c:v>medium</c:v>
                </c:pt>
                <c:pt idx="3">
                  <c:v>fast</c:v>
                </c:pt>
              </c:strCache>
            </c:strRef>
          </c:cat>
          <c:val>
            <c:numRef>
              <c:f>Sheet2!$B$8:$E$8</c:f>
              <c:numCache>
                <c:formatCode>0.00</c:formatCode>
                <c:ptCount val="4"/>
                <c:pt idx="0">
                  <c:v>0.32261904761904769</c:v>
                </c:pt>
                <c:pt idx="1">
                  <c:v>0.25553571428571431</c:v>
                </c:pt>
                <c:pt idx="2">
                  <c:v>0.27184523809523808</c:v>
                </c:pt>
                <c:pt idx="3">
                  <c:v>0.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8F-43FB-9663-F0E84E7C317A}"/>
            </c:ext>
          </c:extLst>
        </c:ser>
        <c:ser>
          <c:idx val="1"/>
          <c:order val="1"/>
          <c:tx>
            <c:strRef>
              <c:f>Sheet2!$A$5</c:f>
              <c:strCache>
                <c:ptCount val="1"/>
                <c:pt idx="0">
                  <c:v>Necker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B$7:$E$7</c:f>
              <c:strCache>
                <c:ptCount val="4"/>
                <c:pt idx="0">
                  <c:v>null</c:v>
                </c:pt>
                <c:pt idx="1">
                  <c:v>slow</c:v>
                </c:pt>
                <c:pt idx="2">
                  <c:v>medium</c:v>
                </c:pt>
                <c:pt idx="3">
                  <c:v>fast</c:v>
                </c:pt>
              </c:strCache>
            </c:strRef>
          </c:cat>
          <c:val>
            <c:numRef>
              <c:f>Sheet2!$B$9:$E$9</c:f>
              <c:numCache>
                <c:formatCode>0.00</c:formatCode>
                <c:ptCount val="4"/>
                <c:pt idx="0">
                  <c:v>0.25555555555555559</c:v>
                </c:pt>
                <c:pt idx="1">
                  <c:v>0.17499999999999996</c:v>
                </c:pt>
                <c:pt idx="2">
                  <c:v>0.2722222222222222</c:v>
                </c:pt>
                <c:pt idx="3">
                  <c:v>0.297222222222222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08F-43FB-9663-F0E84E7C31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43717480"/>
        <c:axId val="943717120"/>
      </c:barChart>
      <c:catAx>
        <c:axId val="9437174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 b="0" i="0" u="none" strike="noStrike" kern="1200" baseline="0" dirty="0">
                    <a:solidFill>
                      <a:srgbClr val="000000"/>
                    </a:solidFill>
                    <a:effectLst/>
                    <a:latin typeface="Aptos Narrow" panose="020B0004020202020204" pitchFamily="34" charset="0"/>
                  </a:rPr>
                  <a:t>Current velocity (</a:t>
                </a:r>
                <a:r>
                  <a:rPr lang="en-GB" sz="1200" b="0" i="0" u="none" strike="noStrike" kern="1200" baseline="0" dirty="0" err="1">
                    <a:solidFill>
                      <a:srgbClr val="000000"/>
                    </a:solidFill>
                    <a:effectLst/>
                    <a:latin typeface="Aptos Narrow" panose="020B0004020202020204" pitchFamily="34" charset="0"/>
                  </a:rPr>
                  <a:t>preferendum</a:t>
                </a:r>
                <a:r>
                  <a:rPr lang="en-GB" sz="1000" b="1" i="0" u="none" strike="noStrike" kern="1200" baseline="0" dirty="0">
                    <a:solidFill>
                      <a:srgbClr val="000000"/>
                    </a:solidFill>
                    <a:effectLst/>
                    <a:latin typeface="Aptos Narrow" panose="020B0004020202020204" pitchFamily="34" charset="0"/>
                  </a:rPr>
                  <a:t>)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43717120"/>
        <c:crosses val="autoZero"/>
        <c:auto val="1"/>
        <c:lblAlgn val="ctr"/>
        <c:lblOffset val="100"/>
        <c:noMultiLvlLbl val="0"/>
      </c:catAx>
      <c:valAx>
        <c:axId val="943717120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43717480"/>
        <c:crosses val="autoZero"/>
        <c:crossBetween val="between"/>
        <c:majorUnit val="0.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486676554570128"/>
          <c:y val="6.179240436971338E-2"/>
          <c:w val="0.81843020242228737"/>
          <c:h val="0.7376712681609023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A$4</c:f>
              <c:strCache>
                <c:ptCount val="1"/>
                <c:pt idx="0">
                  <c:v>Glatt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B$3:$D$3</c:f>
              <c:strCache>
                <c:ptCount val="3"/>
                <c:pt idx="0">
                  <c:v>Lowlands</c:v>
                </c:pt>
                <c:pt idx="1">
                  <c:v>Piedmont level</c:v>
                </c:pt>
                <c:pt idx="2">
                  <c:v>Alpine level</c:v>
                </c:pt>
              </c:strCache>
            </c:strRef>
          </c:cat>
          <c:val>
            <c:numRef>
              <c:f>Sheet2!$B$4:$D$4</c:f>
              <c:numCache>
                <c:formatCode>0.00</c:formatCode>
                <c:ptCount val="3"/>
                <c:pt idx="0">
                  <c:v>0.75437728937728932</c:v>
                </c:pt>
                <c:pt idx="1">
                  <c:v>0.16332417582417583</c:v>
                </c:pt>
                <c:pt idx="2">
                  <c:v>8.229853479853478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465-4533-A2BF-75E37FC7F9DF}"/>
            </c:ext>
          </c:extLst>
        </c:ser>
        <c:ser>
          <c:idx val="1"/>
          <c:order val="1"/>
          <c:tx>
            <c:strRef>
              <c:f>Sheet2!$A$5</c:f>
              <c:strCache>
                <c:ptCount val="1"/>
                <c:pt idx="0">
                  <c:v>Necker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B$3:$D$3</c:f>
              <c:strCache>
                <c:ptCount val="3"/>
                <c:pt idx="0">
                  <c:v>Lowlands</c:v>
                </c:pt>
                <c:pt idx="1">
                  <c:v>Piedmont level</c:v>
                </c:pt>
                <c:pt idx="2">
                  <c:v>Alpine level</c:v>
                </c:pt>
              </c:strCache>
            </c:strRef>
          </c:cat>
          <c:val>
            <c:numRef>
              <c:f>Sheet2!$B$5:$D$5</c:f>
              <c:numCache>
                <c:formatCode>0.00</c:formatCode>
                <c:ptCount val="3"/>
                <c:pt idx="0">
                  <c:v>0.57472527472527468</c:v>
                </c:pt>
                <c:pt idx="1">
                  <c:v>0.28388278388278382</c:v>
                </c:pt>
                <c:pt idx="2">
                  <c:v>0.141391941391941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465-4533-A2BF-75E37FC7F9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43717480"/>
        <c:axId val="943717120"/>
      </c:barChart>
      <c:catAx>
        <c:axId val="9437174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>
                    <a:solidFill>
                      <a:sysClr val="windowText" lastClr="000000"/>
                    </a:solidFill>
                  </a:rPr>
                  <a:t>Altitude</a:t>
                </a:r>
              </a:p>
            </c:rich>
          </c:tx>
          <c:layout>
            <c:manualLayout>
              <c:xMode val="edge"/>
              <c:yMode val="edge"/>
              <c:x val="0.47847521349173727"/>
              <c:y val="0.903788316113714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43717120"/>
        <c:crosses val="autoZero"/>
        <c:auto val="1"/>
        <c:lblAlgn val="ctr"/>
        <c:lblOffset val="100"/>
        <c:noMultiLvlLbl val="0"/>
      </c:catAx>
      <c:valAx>
        <c:axId val="9437171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>
                    <a:solidFill>
                      <a:sysClr val="windowText" lastClr="000000"/>
                    </a:solidFill>
                  </a:rPr>
                  <a:t>Relative</a:t>
                </a:r>
                <a:r>
                  <a:rPr lang="en-GB" sz="1200" baseline="0">
                    <a:solidFill>
                      <a:sysClr val="windowText" lastClr="000000"/>
                    </a:solidFill>
                  </a:rPr>
                  <a:t> afinitiy </a:t>
                </a:r>
                <a:endParaRPr lang="en-GB" sz="120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6.4982041534414666E-3"/>
              <c:y val="0.2562874714205844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43717480"/>
        <c:crosses val="autoZero"/>
        <c:crossBetween val="between"/>
        <c:majorUnit val="0.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868985126859146"/>
          <c:y val="5.6355804443313139E-2"/>
          <c:w val="0.79684121414874953"/>
          <c:h val="0.766534773326787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A$4</c:f>
              <c:strCache>
                <c:ptCount val="1"/>
                <c:pt idx="0">
                  <c:v>Glatt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B$11:$D$11</c:f>
              <c:strCache>
                <c:ptCount val="3"/>
                <c:pt idx="0">
                  <c:v>oligotrophic</c:v>
                </c:pt>
                <c:pt idx="1">
                  <c:v>mesotrophic</c:v>
                </c:pt>
                <c:pt idx="2">
                  <c:v>eutrophic</c:v>
                </c:pt>
              </c:strCache>
            </c:strRef>
          </c:cat>
          <c:val>
            <c:numRef>
              <c:f>Sheet2!$B$12:$D$12</c:f>
              <c:numCache>
                <c:formatCode>0.00</c:formatCode>
                <c:ptCount val="3"/>
                <c:pt idx="0">
                  <c:v>0.34922600619195043</c:v>
                </c:pt>
                <c:pt idx="1">
                  <c:v>0.39798761609907113</c:v>
                </c:pt>
                <c:pt idx="2">
                  <c:v>0.252786377708978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490-4AB7-A3AF-D5A71FBD64B2}"/>
            </c:ext>
          </c:extLst>
        </c:ser>
        <c:ser>
          <c:idx val="1"/>
          <c:order val="1"/>
          <c:tx>
            <c:strRef>
              <c:f>Sheet2!$B$13:$D$13</c:f>
              <c:strCache>
                <c:ptCount val="3"/>
                <c:pt idx="0">
                  <c:v>0.63</c:v>
                </c:pt>
                <c:pt idx="1">
                  <c:v>0.33</c:v>
                </c:pt>
                <c:pt idx="2">
                  <c:v>0.04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B$11:$D$11</c:f>
              <c:strCache>
                <c:ptCount val="3"/>
                <c:pt idx="0">
                  <c:v>oligotrophic</c:v>
                </c:pt>
                <c:pt idx="1">
                  <c:v>mesotrophic</c:v>
                </c:pt>
                <c:pt idx="2">
                  <c:v>eutrophic</c:v>
                </c:pt>
              </c:strCache>
            </c:strRef>
          </c:cat>
          <c:val>
            <c:numRef>
              <c:f>Sheet2!$B$13:$D$13</c:f>
              <c:numCache>
                <c:formatCode>0.00</c:formatCode>
                <c:ptCount val="3"/>
                <c:pt idx="0">
                  <c:v>0.62564102564102564</c:v>
                </c:pt>
                <c:pt idx="1">
                  <c:v>0.32948717948717948</c:v>
                </c:pt>
                <c:pt idx="2">
                  <c:v>4.487179487179486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490-4AB7-A3AF-D5A71FBD64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43717480"/>
        <c:axId val="943717120"/>
      </c:barChart>
      <c:catAx>
        <c:axId val="9437174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 b="0" i="0" u="none" strike="noStrike" kern="1200" baseline="0" dirty="0">
                    <a:solidFill>
                      <a:srgbClr val="000000"/>
                    </a:solidFill>
                    <a:effectLst/>
                    <a:latin typeface="Aptos Narrow" panose="020B0004020202020204" pitchFamily="34" charset="0"/>
                  </a:rPr>
                  <a:t>Trophic status (</a:t>
                </a:r>
                <a:r>
                  <a:rPr lang="en-GB" sz="1200" b="0" i="0" u="none" strike="noStrike" kern="1200" baseline="0" dirty="0" err="1">
                    <a:solidFill>
                      <a:srgbClr val="000000"/>
                    </a:solidFill>
                    <a:effectLst/>
                    <a:latin typeface="Aptos Narrow" panose="020B0004020202020204" pitchFamily="34" charset="0"/>
                  </a:rPr>
                  <a:t>preferendum</a:t>
                </a:r>
                <a:r>
                  <a:rPr lang="en-GB" sz="1200" b="0" i="0" u="none" strike="noStrike" kern="1200" baseline="0" dirty="0">
                    <a:solidFill>
                      <a:srgbClr val="000000"/>
                    </a:solidFill>
                    <a:effectLst/>
                    <a:latin typeface="Aptos Narrow" panose="020B0004020202020204" pitchFamily="34" charset="0"/>
                  </a:rPr>
                  <a:t>)</a:t>
                </a:r>
                <a:r>
                  <a:rPr lang="en-GB" sz="1000" b="0" i="0" u="none" strike="noStrike" kern="1200" baseline="0" dirty="0">
                    <a:solidFill>
                      <a:srgbClr val="000000"/>
                    </a:solidFill>
                    <a:effectLst/>
                    <a:latin typeface="Aptos Narrow" panose="020B0004020202020204" pitchFamily="34" charset="0"/>
                  </a:rPr>
                  <a:t>)</a:t>
                </a:r>
                <a:endParaRPr lang="en-US" b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43717120"/>
        <c:crosses val="autoZero"/>
        <c:auto val="1"/>
        <c:lblAlgn val="ctr"/>
        <c:lblOffset val="100"/>
        <c:noMultiLvlLbl val="0"/>
      </c:catAx>
      <c:valAx>
        <c:axId val="9437171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>
                    <a:solidFill>
                      <a:sysClr val="windowText" lastClr="000000"/>
                    </a:solidFill>
                  </a:rPr>
                  <a:t>Relative</a:t>
                </a:r>
                <a:r>
                  <a:rPr lang="en-GB" sz="1200" baseline="0">
                    <a:solidFill>
                      <a:sysClr val="windowText" lastClr="000000"/>
                    </a:solidFill>
                  </a:rPr>
                  <a:t> afinitiy </a:t>
                </a:r>
                <a:endParaRPr lang="en-GB" sz="120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1.662049861495845E-2"/>
              <c:y val="0.2562874714205844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43717480"/>
        <c:crosses val="autoZero"/>
        <c:crossBetween val="between"/>
        <c:majorUnit val="0.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CB9C61-BEE0-4DB9-9805-2763D58AAB00}" type="datetimeFigureOut">
              <a:rPr lang="en-GB" smtClean="0"/>
              <a:t>15/07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490C91-DEC8-455D-9565-6E8AAB6792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90642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490C91-DEC8-455D-9565-6E8AAB6792B1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28315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20E5-DC64-418D-BDDD-94B5C4A2574A}" type="datetimeFigureOut">
              <a:rPr lang="en-GB" smtClean="0"/>
              <a:t>15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673A5-AC65-44AB-B5DB-0CDF61BBC0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1846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20E5-DC64-418D-BDDD-94B5C4A2574A}" type="datetimeFigureOut">
              <a:rPr lang="en-GB" smtClean="0"/>
              <a:t>15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673A5-AC65-44AB-B5DB-0CDF61BBC0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748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20E5-DC64-418D-BDDD-94B5C4A2574A}" type="datetimeFigureOut">
              <a:rPr lang="en-GB" smtClean="0"/>
              <a:t>15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673A5-AC65-44AB-B5DB-0CDF61BBC0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3629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20E5-DC64-418D-BDDD-94B5C4A2574A}" type="datetimeFigureOut">
              <a:rPr lang="en-GB" smtClean="0"/>
              <a:t>15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673A5-AC65-44AB-B5DB-0CDF61BBC0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8747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20E5-DC64-418D-BDDD-94B5C4A2574A}" type="datetimeFigureOut">
              <a:rPr lang="en-GB" smtClean="0"/>
              <a:t>15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673A5-AC65-44AB-B5DB-0CDF61BBC0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95678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20E5-DC64-418D-BDDD-94B5C4A2574A}" type="datetimeFigureOut">
              <a:rPr lang="en-GB" smtClean="0"/>
              <a:t>15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673A5-AC65-44AB-B5DB-0CDF61BBC0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1380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20E5-DC64-418D-BDDD-94B5C4A2574A}" type="datetimeFigureOut">
              <a:rPr lang="en-GB" smtClean="0"/>
              <a:t>15/07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673A5-AC65-44AB-B5DB-0CDF61BBC0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184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20E5-DC64-418D-BDDD-94B5C4A2574A}" type="datetimeFigureOut">
              <a:rPr lang="en-GB" smtClean="0"/>
              <a:t>15/07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673A5-AC65-44AB-B5DB-0CDF61BBC0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5862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20E5-DC64-418D-BDDD-94B5C4A2574A}" type="datetimeFigureOut">
              <a:rPr lang="en-GB" smtClean="0"/>
              <a:t>15/07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673A5-AC65-44AB-B5DB-0CDF61BBC0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9896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20E5-DC64-418D-BDDD-94B5C4A2574A}" type="datetimeFigureOut">
              <a:rPr lang="en-GB" smtClean="0"/>
              <a:t>15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673A5-AC65-44AB-B5DB-0CDF61BBC0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2432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20E5-DC64-418D-BDDD-94B5C4A2574A}" type="datetimeFigureOut">
              <a:rPr lang="en-GB" smtClean="0"/>
              <a:t>15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673A5-AC65-44AB-B5DB-0CDF61BBC0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2091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B220E5-DC64-418D-BDDD-94B5C4A2574A}" type="datetimeFigureOut">
              <a:rPr lang="en-GB" smtClean="0"/>
              <a:t>15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6673A5-AC65-44AB-B5DB-0CDF61BBC0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5615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F17D26-E11A-8C74-DE08-291B2992B8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39565" y="383948"/>
            <a:ext cx="5915025" cy="1648298"/>
          </a:xfrm>
        </p:spPr>
        <p:txBody>
          <a:bodyPr>
            <a:normAutofit fontScale="90000"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 for </a:t>
            </a:r>
            <a:r>
              <a:rPr lang="en-GB" sz="11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”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ow effective are ecological metrics in supporting conservation and management in degraded streams?”</a:t>
            </a:r>
            <a:br>
              <a:rPr lang="en-GB" sz="11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GB" sz="11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Kate L. Mathers, Christopher T. Robinson, Matthew Hill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1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Carmen Kowarik, Jani Heino, </a:t>
            </a:r>
            <a:r>
              <a:rPr lang="en-GB" sz="11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arl</a:t>
            </a:r>
            <a:r>
              <a:rPr lang="en-GB" sz="11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eacon, Christine Weber</a:t>
            </a:r>
            <a:br>
              <a:rPr lang="en-GB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br>
              <a:rPr lang="en-GB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GB" dirty="0"/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562C285-371D-6C8D-1217-18B3C4DB08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459750"/>
              </p:ext>
            </p:extLst>
          </p:nvPr>
        </p:nvGraphicFramePr>
        <p:xfrm>
          <a:off x="339565" y="1698764"/>
          <a:ext cx="5850187" cy="6948440"/>
        </p:xfrm>
        <a:graphic>
          <a:graphicData uri="http://schemas.openxmlformats.org/drawingml/2006/table">
            <a:tbl>
              <a:tblPr/>
              <a:tblGrid>
                <a:gridCol w="1587791">
                  <a:extLst>
                    <a:ext uri="{9D8B030D-6E8A-4147-A177-3AD203B41FA5}">
                      <a16:colId xmlns:a16="http://schemas.microsoft.com/office/drawing/2014/main" val="2543723649"/>
                    </a:ext>
                  </a:extLst>
                </a:gridCol>
                <a:gridCol w="1587791">
                  <a:extLst>
                    <a:ext uri="{9D8B030D-6E8A-4147-A177-3AD203B41FA5}">
                      <a16:colId xmlns:a16="http://schemas.microsoft.com/office/drawing/2014/main" val="346421941"/>
                    </a:ext>
                  </a:extLst>
                </a:gridCol>
                <a:gridCol w="1335934">
                  <a:extLst>
                    <a:ext uri="{9D8B030D-6E8A-4147-A177-3AD203B41FA5}">
                      <a16:colId xmlns:a16="http://schemas.microsoft.com/office/drawing/2014/main" val="1809507094"/>
                    </a:ext>
                  </a:extLst>
                </a:gridCol>
                <a:gridCol w="1338671">
                  <a:extLst>
                    <a:ext uri="{9D8B030D-6E8A-4147-A177-3AD203B41FA5}">
                      <a16:colId xmlns:a16="http://schemas.microsoft.com/office/drawing/2014/main" val="219733266"/>
                    </a:ext>
                  </a:extLst>
                </a:gridCol>
              </a:tblGrid>
              <a:tr h="273674">
                <a:tc gridSpan="4"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1.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croinvertebrate functional traits examined in this study (taken from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het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et al., 2010).</a:t>
                      </a: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3040092"/>
                  </a:ext>
                </a:extLst>
              </a:tr>
              <a:tr h="1521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ouping feature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it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ouping feature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it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9127089"/>
                  </a:ext>
                </a:extLst>
              </a:tr>
              <a:tr h="152126">
                <a:tc rowSpan="7"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ximum potential size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≤0.25cm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iration method 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ill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2464693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0.25- 0.5cm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tron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5819244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0.5- 1cm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iracle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580540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- 2cm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drostatic vesicle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0047411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 2- 4 cm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gument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8362799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4- 8cm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9"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od consumed </a:t>
                      </a:r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croorganisms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4695267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8cm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tritus &lt;1mm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9141045"/>
                  </a:ext>
                </a:extLst>
              </a:tr>
              <a:tr h="15212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fe-cycle duration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≤1 year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ad plant ≥1mm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4973416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 year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ing microphyte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7886277"/>
                  </a:ext>
                </a:extLst>
              </a:tr>
              <a:tr h="15212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oltinism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1 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ing macrophtye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609433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ad animal ≥1mm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8769859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1 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ing microinvertebrate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7995362"/>
                  </a:ext>
                </a:extLst>
              </a:tr>
              <a:tr h="152126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quatic stages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g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ing invertebrate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1386286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rva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rtebrate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2284149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ymph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8"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eding group </a:t>
                      </a:r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sorb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0443302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ult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posit feed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02694"/>
                  </a:ext>
                </a:extLst>
              </a:tr>
              <a:tr h="152126">
                <a:tc rowSpan="8"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production strategy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oviviparity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redd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4407126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olated, free eggs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rap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4672150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olated, cemented eggs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lter-feed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217760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tches, cemented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erc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2864982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tches, free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dato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5313733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tches, in vegetation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rasite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1974520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tches, terrestrial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14">
                  <a:txBody>
                    <a:bodyPr/>
                    <a:lstStyle/>
                    <a:p>
                      <a:pPr algn="ctr" rtl="0" fontAlgn="ctr"/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6834312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exual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1022561"/>
                  </a:ext>
                </a:extLst>
              </a:tr>
              <a:tr h="152126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spersal strategy 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quatic passive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324967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quatic active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5238754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erial passive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5730691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erial active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8657322"/>
                  </a:ext>
                </a:extLst>
              </a:tr>
              <a:tr h="152126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istance form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gs/statoblasts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2162881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coons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9134096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usings against desiccation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9556194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apause / dormancy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63903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ne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8343360"/>
                  </a:ext>
                </a:extLst>
              </a:tr>
              <a:tr h="152126">
                <a:tc rowSpan="8"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omotion and substrate relation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ier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3357246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face swimmer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rtl="0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4690535"/>
                  </a:ext>
                </a:extLst>
              </a:tr>
              <a:tr h="1599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ll water swimmer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8220411"/>
                  </a:ext>
                </a:extLst>
              </a:tr>
              <a:tr h="1599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awler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1021274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rrower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81136"/>
                  </a:ext>
                </a:extLst>
              </a:tr>
              <a:tr h="1599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stitial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5931577"/>
                  </a:ext>
                </a:extLst>
              </a:tr>
              <a:tr h="15991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mporarily attached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8212980"/>
                  </a:ext>
                </a:extLst>
              </a:tr>
              <a:tr h="15212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rmanently attached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419" marR="6419" marT="641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419" marR="6419" marT="64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57867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811467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6B10019-72DD-6989-A7AE-B79783C44207}"/>
              </a:ext>
            </a:extLst>
          </p:cNvPr>
          <p:cNvSpPr txBox="1"/>
          <p:nvPr/>
        </p:nvSpPr>
        <p:spPr>
          <a:xfrm>
            <a:off x="801396" y="5698273"/>
            <a:ext cx="525520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an (±1 SE) a) Total Phosphorus (mg/L), b) Total Nitrogen, c) Total fine sediment (g m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, and d)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fankuch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dex for the Glatt and Necker rivers. 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ote, the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fankuch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dex only includes main 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em 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ites on each river.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group of graphs showing different types of nitrogen&#10;&#10;Description automatically generated with medium confidence">
            <a:extLst>
              <a:ext uri="{FF2B5EF4-FFF2-40B4-BE49-F238E27FC236}">
                <a16:creationId xmlns:a16="http://schemas.microsoft.com/office/drawing/2014/main" id="{AE8BE167-9C84-48A7-0674-114D49F92C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097" y="188559"/>
            <a:ext cx="5429160" cy="54291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21621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graph of a number of dots&#10;&#10;Description automatically generated with medium confidence">
            <a:extLst>
              <a:ext uri="{FF2B5EF4-FFF2-40B4-BE49-F238E27FC236}">
                <a16:creationId xmlns:a16="http://schemas.microsoft.com/office/drawing/2014/main" id="{36FF0558-68C0-C481-0A56-D7E6991A063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3537" y="349681"/>
            <a:ext cx="3772150" cy="3772150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5427926-76A8-BA34-2AD2-AC3858599D22}"/>
              </a:ext>
            </a:extLst>
          </p:cNvPr>
          <p:cNvSpPr txBox="1"/>
          <p:nvPr/>
        </p:nvSpPr>
        <p:spPr>
          <a:xfrm>
            <a:off x="912009" y="4121831"/>
            <a:ext cx="52552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on-metric multidimensional scaling (NMDS) of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</a:rPr>
              <a:t>the eight final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nvironmental variables in the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Glatt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(grey) and Necker (orange) rivers. Note, the </a:t>
            </a:r>
            <a:r>
              <a:rPr lang="en-GB" sz="1200" kern="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fankuch</a:t>
            </a:r>
            <a:r>
              <a:rPr lang="en-GB" sz="1200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index </a:t>
            </a:r>
            <a:r>
              <a:rPr lang="en-GB" sz="1200" kern="0" dirty="0">
                <a:latin typeface="Arial" panose="020B0604020202020204" pitchFamily="34" charset="0"/>
                <a:ea typeface="Calibri" panose="020F0502020204030204" pitchFamily="34" charset="0"/>
              </a:rPr>
              <a:t>is not included in this analysis.</a:t>
            </a:r>
          </a:p>
        </p:txBody>
      </p:sp>
    </p:spTree>
    <p:extLst>
      <p:ext uri="{BB962C8B-B14F-4D97-AF65-F5344CB8AC3E}">
        <p14:creationId xmlns:p14="http://schemas.microsoft.com/office/powerpoint/2010/main" val="2320408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8">
            <a:extLst>
              <a:ext uri="{FF2B5EF4-FFF2-40B4-BE49-F238E27FC236}">
                <a16:creationId xmlns:a16="http://schemas.microsoft.com/office/drawing/2014/main" id="{DF5907A1-C77C-0A41-975E-5DD7E0DDF1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6788" y="191069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9" name="Rectangle 9">
            <a:extLst>
              <a:ext uri="{FF2B5EF4-FFF2-40B4-BE49-F238E27FC236}">
                <a16:creationId xmlns:a16="http://schemas.microsoft.com/office/drawing/2014/main" id="{07485093-5D1B-368E-8B48-CCE2FED4AF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6788" y="648269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0" name="Rectangle 10">
            <a:extLst>
              <a:ext uri="{FF2B5EF4-FFF2-40B4-BE49-F238E27FC236}">
                <a16:creationId xmlns:a16="http://schemas.microsoft.com/office/drawing/2014/main" id="{99DAD42B-DD76-A40B-DEDE-87D2380EA1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6788" y="3077144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1" name="Rectangle 11">
            <a:extLst>
              <a:ext uri="{FF2B5EF4-FFF2-40B4-BE49-F238E27FC236}">
                <a16:creationId xmlns:a16="http://schemas.microsoft.com/office/drawing/2014/main" id="{BCCE672E-5364-87D4-6A31-9FDBC9408B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6788" y="3077144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2" name="Rectangle 12">
            <a:extLst>
              <a:ext uri="{FF2B5EF4-FFF2-40B4-BE49-F238E27FC236}">
                <a16:creationId xmlns:a16="http://schemas.microsoft.com/office/drawing/2014/main" id="{DD45631B-A106-90B0-4856-0CB7228099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6788" y="5534594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3" name="Rectangle 13">
            <a:extLst>
              <a:ext uri="{FF2B5EF4-FFF2-40B4-BE49-F238E27FC236}">
                <a16:creationId xmlns:a16="http://schemas.microsoft.com/office/drawing/2014/main" id="{31C08CF1-FCD9-0B16-4F30-62B3DC1635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6788" y="5534594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4" name="Rectangle 14">
            <a:extLst>
              <a:ext uri="{FF2B5EF4-FFF2-40B4-BE49-F238E27FC236}">
                <a16:creationId xmlns:a16="http://schemas.microsoft.com/office/drawing/2014/main" id="{8CDA418E-23F7-87E6-4CF7-3BBC8C173A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6788" y="7925369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6C14631-F88D-3945-71C2-2996E88B778F}"/>
              </a:ext>
            </a:extLst>
          </p:cNvPr>
          <p:cNvSpPr txBox="1"/>
          <p:nvPr/>
        </p:nvSpPr>
        <p:spPr>
          <a:xfrm>
            <a:off x="716293" y="3749773"/>
            <a:ext cx="525520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GB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</a:t>
            </a:r>
            <a:r>
              <a:rPr lang="en-GB" sz="12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GB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xplot of the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local contribution to environmental heterogeneity (LCEH)</a:t>
            </a:r>
            <a:r>
              <a:rPr lang="en-GB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corded from the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att</a:t>
            </a:r>
            <a:r>
              <a:rPr lang="en-GB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Necker rivers (boxes show 25th, 50th and 75th percentiles, upper whiskers shows 75th percentile + 1.5 * IQR, and the lower whisker shows the 25th percentile -1.5 * IQR).</a:t>
            </a:r>
          </a:p>
        </p:txBody>
      </p:sp>
      <p:pic>
        <p:nvPicPr>
          <p:cNvPr id="3" name="Picture 2" descr="A graph with lines and dots&#10;&#10;Description automatically generated">
            <a:extLst>
              <a:ext uri="{FF2B5EF4-FFF2-40B4-BE49-F238E27FC236}">
                <a16:creationId xmlns:a16="http://schemas.microsoft.com/office/drawing/2014/main" id="{65BD025E-614C-A7C0-B26B-1E238F817A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6788" y="274351"/>
            <a:ext cx="3394312" cy="33943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83472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number of sites&#10;&#10;Description automatically generated">
            <a:extLst>
              <a:ext uri="{FF2B5EF4-FFF2-40B4-BE49-F238E27FC236}">
                <a16:creationId xmlns:a16="http://schemas.microsoft.com/office/drawing/2014/main" id="{CC3B3306-38EA-2935-9781-F9874FD5E0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0150" y="295275"/>
            <a:ext cx="4457700" cy="44577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4E66E0C-1F62-2997-EFFE-06EF58BF31FD}"/>
              </a:ext>
            </a:extLst>
          </p:cNvPr>
          <p:cNvSpPr txBox="1"/>
          <p:nvPr/>
        </p:nvSpPr>
        <p:spPr>
          <a:xfrm>
            <a:off x="999095" y="4862060"/>
            <a:ext cx="52552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</a:t>
            </a:r>
            <a:r>
              <a:rPr lang="en-GB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pecies accumulation curves of macroinvertebrate richness for each </a:t>
            </a:r>
            <a:r>
              <a:rPr lang="en-GB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iver (grey fill = </a:t>
            </a:r>
            <a:r>
              <a:rPr lang="en-GB" sz="1200" kern="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att</a:t>
            </a:r>
            <a:r>
              <a:rPr lang="en-GB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black </a:t>
            </a:r>
            <a:r>
              <a:rPr lang="en-GB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ll = Necker).</a:t>
            </a:r>
          </a:p>
        </p:txBody>
      </p:sp>
    </p:spTree>
    <p:extLst>
      <p:ext uri="{BB962C8B-B14F-4D97-AF65-F5344CB8AC3E}">
        <p14:creationId xmlns:p14="http://schemas.microsoft.com/office/powerpoint/2010/main" val="21455101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092C07B-797A-9381-AF48-31D6760DBEF6}"/>
              </a:ext>
            </a:extLst>
          </p:cNvPr>
          <p:cNvSpPr txBox="1"/>
          <p:nvPr/>
        </p:nvSpPr>
        <p:spPr>
          <a:xfrm>
            <a:off x="716293" y="3749773"/>
            <a:ext cx="525520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GB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</a:t>
            </a:r>
            <a:r>
              <a:rPr lang="en-GB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xplot of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axonomic multivariate dispersion </a:t>
            </a:r>
            <a:r>
              <a:rPr lang="en-GB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corded from the Glatt and Necker </a:t>
            </a:r>
            <a:r>
              <a:rPr lang="en-GB" sz="12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ivers (boxes show 25th, 50th and 75th percentiles, upper whiskers shows 75th percentile + 1.5 * IQR, and the lower whisker shows the 25th percentile -1.5 * IQR).</a:t>
            </a:r>
            <a:endParaRPr lang="en-GB" sz="12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graph of a diagram&#10;&#10;Description automatically generated">
            <a:extLst>
              <a:ext uri="{FF2B5EF4-FFF2-40B4-BE49-F238E27FC236}">
                <a16:creationId xmlns:a16="http://schemas.microsoft.com/office/drawing/2014/main" id="{3553758C-32B0-52CB-947E-AE54CBE2FD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6783" y="556898"/>
            <a:ext cx="3034807" cy="303480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0518070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3122A8EF-49B0-41C1-8A9B-8063192579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0124056"/>
              </p:ext>
            </p:extLst>
          </p:nvPr>
        </p:nvGraphicFramePr>
        <p:xfrm>
          <a:off x="3290396" y="2878180"/>
          <a:ext cx="3491564" cy="32308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5606CCFB-1F65-4E1A-8171-41E0E6DE5DA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5563348"/>
              </p:ext>
            </p:extLst>
          </p:nvPr>
        </p:nvGraphicFramePr>
        <p:xfrm>
          <a:off x="3252375" y="299572"/>
          <a:ext cx="3529584" cy="24915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DC7EE90F-C254-DDCC-05A6-8D3026CCCB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250361"/>
              </p:ext>
            </p:extLst>
          </p:nvPr>
        </p:nvGraphicFramePr>
        <p:xfrm>
          <a:off x="76041" y="343112"/>
          <a:ext cx="3453543" cy="24915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B5EC9191-0670-4767-A9E6-48FBDD9D3F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5228631"/>
              </p:ext>
            </p:extLst>
          </p:nvPr>
        </p:nvGraphicFramePr>
        <p:xfrm>
          <a:off x="0" y="2878180"/>
          <a:ext cx="3529584" cy="2571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67D0162B-DB1C-42A4-EAFF-427D8EC95FE4}"/>
              </a:ext>
            </a:extLst>
          </p:cNvPr>
          <p:cNvSpPr txBox="1"/>
          <p:nvPr/>
        </p:nvSpPr>
        <p:spPr>
          <a:xfrm>
            <a:off x="345742" y="6196120"/>
            <a:ext cx="61665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GB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6.</a:t>
            </a:r>
            <a:r>
              <a:rPr lang="en-GB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lative affinity of all unique taxa recorded in Glatt (grey) and Necker (orange) to the biological preferences of a) Altitude; b) current velocity, c) trophic status and d) substrate (as defined by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Tachet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et al., 2010).</a:t>
            </a:r>
            <a:endParaRPr lang="en-GB" sz="12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F911137-76C5-5033-F3D0-6403FC03112D}"/>
              </a:ext>
            </a:extLst>
          </p:cNvPr>
          <p:cNvSpPr txBox="1"/>
          <p:nvPr/>
        </p:nvSpPr>
        <p:spPr>
          <a:xfrm>
            <a:off x="418214" y="198474"/>
            <a:ext cx="588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a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43FBBFC-AA3F-3068-8F00-30EF515FC96A}"/>
              </a:ext>
            </a:extLst>
          </p:cNvPr>
          <p:cNvSpPr txBox="1"/>
          <p:nvPr/>
        </p:nvSpPr>
        <p:spPr>
          <a:xfrm>
            <a:off x="3727464" y="161072"/>
            <a:ext cx="588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b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2B70B6E-EB0D-B17F-E719-BB118AC6ADBC}"/>
              </a:ext>
            </a:extLst>
          </p:cNvPr>
          <p:cNvSpPr txBox="1"/>
          <p:nvPr/>
        </p:nvSpPr>
        <p:spPr>
          <a:xfrm>
            <a:off x="410106" y="2696140"/>
            <a:ext cx="588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c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B181427-BDAA-89F3-BCC2-D266B08F6ACB}"/>
              </a:ext>
            </a:extLst>
          </p:cNvPr>
          <p:cNvSpPr txBox="1"/>
          <p:nvPr/>
        </p:nvSpPr>
        <p:spPr>
          <a:xfrm>
            <a:off x="3774048" y="2696140"/>
            <a:ext cx="588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d)</a:t>
            </a:r>
          </a:p>
        </p:txBody>
      </p:sp>
    </p:spTree>
    <p:extLst>
      <p:ext uri="{BB962C8B-B14F-4D97-AF65-F5344CB8AC3E}">
        <p14:creationId xmlns:p14="http://schemas.microsoft.com/office/powerpoint/2010/main" val="18413945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  <a:fontScheme name="Office">
    <a:majorFont>
      <a:latin typeface="Aptos Display" panose="0211000402020202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Aptos Narrow" panose="0211000402020202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  <a:fontScheme name="Office">
    <a:majorFont>
      <a:latin typeface="Aptos Display" panose="0211000402020202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Aptos Narrow" panose="0211000402020202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7</TotalTime>
  <Words>526</Words>
  <Application>Microsoft Office PowerPoint</Application>
  <PresentationFormat>On-screen Show (4:3)</PresentationFormat>
  <Paragraphs>99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ptos</vt:lpstr>
      <vt:lpstr>Aptos Narrow</vt:lpstr>
      <vt:lpstr>Arial</vt:lpstr>
      <vt:lpstr>Calibri</vt:lpstr>
      <vt:lpstr>Calibri Light</vt:lpstr>
      <vt:lpstr>Office Theme</vt:lpstr>
      <vt:lpstr>Supplementary material for  ” How effective are ecological metrics in supporting conservation and management in degraded streams?”  Kate L. Mathers, Christopher T. Robinson, Matthew Hill ,Carmen Kowarik, Jani Heino, Charl Deacon, Christine Weber  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Mathers</dc:creator>
  <cp:lastModifiedBy>Kate Mathers</cp:lastModifiedBy>
  <cp:revision>39</cp:revision>
  <dcterms:created xsi:type="dcterms:W3CDTF">2023-08-11T12:20:03Z</dcterms:created>
  <dcterms:modified xsi:type="dcterms:W3CDTF">2024-07-15T12:51:30Z</dcterms:modified>
</cp:coreProperties>
</file>